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9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027EA7B-7F24-0ABD-6537-DBADD8D8F587}" v="2" dt="2019-10-07T02:34:20.464"/>
    <p1510:client id="{3616BD1D-5CCC-51FB-26E6-EA58CE489414}" v="5" dt="2019-10-07T02:46:09.278"/>
    <p1510:client id="{ABD2D9A6-6AE6-4DAE-7E6E-EB84A508C742}" v="7" dt="2019-10-07T02:31:06.965"/>
    <p1510:client id="{B1227DA5-5ACA-AFBA-7F14-27659559053A}" v="3" dt="2019-09-06T04:20:17.706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5498" autoAdjust="0"/>
    <p:restoredTop sz="96834" autoAdjust="0"/>
  </p:normalViewPr>
  <p:slideViewPr>
    <p:cSldViewPr snapToGrid="0">
      <p:cViewPr varScale="1">
        <p:scale>
          <a:sx n="125" d="100"/>
          <a:sy n="125" d="100"/>
        </p:scale>
        <p:origin x="1008" y="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29" Type="http://schemas.microsoft.com/office/2016/11/relationships/changesInfo" Target="changesInfos/changesInfo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28" Type="http://schemas.microsoft.com/office/2015/10/relationships/revisionInfo" Target="revisionInfo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HINKAWA Satoru" userId="S::323329@jp.honda-ri.com::c45c76bf-e864-4554-8776-a99736ef45b7" providerId="AD" clId="Web-{C4105132-E7A9-E907-FE9E-31E6CDF6AA78}"/>
    <pc:docChg chg="modSld">
      <pc:chgData name="SHINKAWA Satoru" userId="S::323329@jp.honda-ri.com::c45c76bf-e864-4554-8776-a99736ef45b7" providerId="AD" clId="Web-{C4105132-E7A9-E907-FE9E-31E6CDF6AA78}" dt="2019-07-17T08:45:33.851" v="7"/>
      <pc:docMkLst>
        <pc:docMk/>
      </pc:docMkLst>
      <pc:sldChg chg="addSp delSp modSp">
        <pc:chgData name="SHINKAWA Satoru" userId="S::323329@jp.honda-ri.com::c45c76bf-e864-4554-8776-a99736ef45b7" providerId="AD" clId="Web-{C4105132-E7A9-E907-FE9E-31E6CDF6AA78}" dt="2019-07-17T08:45:33.851" v="7"/>
        <pc:sldMkLst>
          <pc:docMk/>
          <pc:sldMk cId="2558221072" sldId="257"/>
        </pc:sldMkLst>
        <pc:picChg chg="add del mod">
          <ac:chgData name="SHINKAWA Satoru" userId="S::323329@jp.honda-ri.com::c45c76bf-e864-4554-8776-a99736ef45b7" providerId="AD" clId="Web-{C4105132-E7A9-E907-FE9E-31E6CDF6AA78}" dt="2019-07-17T08:45:23.867" v="3"/>
          <ac:picMkLst>
            <pc:docMk/>
            <pc:sldMk cId="2558221072" sldId="257"/>
            <ac:picMk id="3" creationId="{E6B60ACA-50DC-403D-826E-137E9C695164}"/>
          </ac:picMkLst>
        </pc:picChg>
        <pc:picChg chg="del">
          <ac:chgData name="SHINKAWA Satoru" userId="S::323329@jp.honda-ri.com::c45c76bf-e864-4554-8776-a99736ef45b7" providerId="AD" clId="Web-{C4105132-E7A9-E907-FE9E-31E6CDF6AA78}" dt="2019-07-17T08:45:09.648" v="0"/>
          <ac:picMkLst>
            <pc:docMk/>
            <pc:sldMk cId="2558221072" sldId="257"/>
            <ac:picMk id="4" creationId="{00000000-0000-0000-0000-000000000000}"/>
          </ac:picMkLst>
        </pc:picChg>
        <pc:picChg chg="add del mod">
          <ac:chgData name="SHINKAWA Satoru" userId="S::323329@jp.honda-ri.com::c45c76bf-e864-4554-8776-a99736ef45b7" providerId="AD" clId="Web-{C4105132-E7A9-E907-FE9E-31E6CDF6AA78}" dt="2019-07-17T08:45:27.851" v="5"/>
          <ac:picMkLst>
            <pc:docMk/>
            <pc:sldMk cId="2558221072" sldId="257"/>
            <ac:picMk id="7" creationId="{DA281D69-2AF9-4E9D-87E9-C366A9C56730}"/>
          </ac:picMkLst>
        </pc:picChg>
        <pc:picChg chg="add del mod">
          <ac:chgData name="SHINKAWA Satoru" userId="S::323329@jp.honda-ri.com::c45c76bf-e864-4554-8776-a99736ef45b7" providerId="AD" clId="Web-{C4105132-E7A9-E907-FE9E-31E6CDF6AA78}" dt="2019-07-17T08:45:33.851" v="7"/>
          <ac:picMkLst>
            <pc:docMk/>
            <pc:sldMk cId="2558221072" sldId="257"/>
            <ac:picMk id="12" creationId="{046BD05E-E883-410A-A0F3-37195E958E1C}"/>
          </ac:picMkLst>
        </pc:picChg>
      </pc:sldChg>
    </pc:docChg>
  </pc:docChgLst>
  <pc:docChgLst>
    <pc:chgData name="SHINKAWA Satoru" userId="S::323329@jp.honda-ri.com::c45c76bf-e864-4554-8776-a99736ef45b7" providerId="AD" clId="Web-{3616BD1D-5CCC-51FB-26E6-EA58CE489414}"/>
    <pc:docChg chg="modSld">
      <pc:chgData name="SHINKAWA Satoru" userId="S::323329@jp.honda-ri.com::c45c76bf-e864-4554-8776-a99736ef45b7" providerId="AD" clId="Web-{3616BD1D-5CCC-51FB-26E6-EA58CE489414}" dt="2019-10-07T02:46:09.278" v="4"/>
      <pc:docMkLst>
        <pc:docMk/>
      </pc:docMkLst>
      <pc:sldChg chg="delSp modSp">
        <pc:chgData name="SHINKAWA Satoru" userId="S::323329@jp.honda-ri.com::c45c76bf-e864-4554-8776-a99736ef45b7" providerId="AD" clId="Web-{3616BD1D-5CCC-51FB-26E6-EA58CE489414}" dt="2019-10-07T02:46:09.278" v="4"/>
        <pc:sldMkLst>
          <pc:docMk/>
          <pc:sldMk cId="3602664236" sldId="288"/>
        </pc:sldMkLst>
        <pc:spChg chg="del mod">
          <ac:chgData name="SHINKAWA Satoru" userId="S::323329@jp.honda-ri.com::c45c76bf-e864-4554-8776-a99736ef45b7" providerId="AD" clId="Web-{3616BD1D-5CCC-51FB-26E6-EA58CE489414}" dt="2019-10-07T02:46:09.278" v="4"/>
          <ac:spMkLst>
            <pc:docMk/>
            <pc:sldMk cId="3602664236" sldId="288"/>
            <ac:spMk id="2" creationId="{00000000-0000-0000-0000-000000000000}"/>
          </ac:spMkLst>
        </pc:spChg>
      </pc:sldChg>
    </pc:docChg>
  </pc:docChgLst>
  <pc:docChgLst>
    <pc:chgData name="MITSUZAWA Shigenobu" userId="S::722940@jp.honda-ri.com::dea47e31-a259-4843-91ca-0f6173b4ded7" providerId="AD" clId="Web-{ABD2D9A6-6AE6-4DAE-7E6E-EB84A508C742}"/>
    <pc:docChg chg="delSld modSld">
      <pc:chgData name="MITSUZAWA Shigenobu" userId="S::722940@jp.honda-ri.com::dea47e31-a259-4843-91ca-0f6173b4ded7" providerId="AD" clId="Web-{ABD2D9A6-6AE6-4DAE-7E6E-EB84A508C742}" dt="2019-10-07T02:31:06.965" v="6"/>
      <pc:docMkLst>
        <pc:docMk/>
      </pc:docMkLst>
      <pc:sldChg chg="del">
        <pc:chgData name="MITSUZAWA Shigenobu" userId="S::722940@jp.honda-ri.com::dea47e31-a259-4843-91ca-0f6173b4ded7" providerId="AD" clId="Web-{ABD2D9A6-6AE6-4DAE-7E6E-EB84A508C742}" dt="2019-10-07T02:30:51.840" v="0"/>
        <pc:sldMkLst>
          <pc:docMk/>
          <pc:sldMk cId="2201234747" sldId="284"/>
        </pc:sldMkLst>
      </pc:sldChg>
      <pc:sldChg chg="del">
        <pc:chgData name="MITSUZAWA Shigenobu" userId="S::722940@jp.honda-ri.com::dea47e31-a259-4843-91ca-0f6173b4ded7" providerId="AD" clId="Web-{ABD2D9A6-6AE6-4DAE-7E6E-EB84A508C742}" dt="2019-10-07T02:30:52.809" v="1"/>
        <pc:sldMkLst>
          <pc:docMk/>
          <pc:sldMk cId="4282462745" sldId="285"/>
        </pc:sldMkLst>
      </pc:sldChg>
      <pc:sldChg chg="delSp modSp">
        <pc:chgData name="MITSUZAWA Shigenobu" userId="S::722940@jp.honda-ri.com::dea47e31-a259-4843-91ca-0f6173b4ded7" providerId="AD" clId="Web-{ABD2D9A6-6AE6-4DAE-7E6E-EB84A508C742}" dt="2019-10-07T02:31:06.965" v="6"/>
        <pc:sldMkLst>
          <pc:docMk/>
          <pc:sldMk cId="3602664236" sldId="288"/>
        </pc:sldMkLst>
        <pc:spChg chg="del mod">
          <ac:chgData name="MITSUZAWA Shigenobu" userId="S::722940@jp.honda-ri.com::dea47e31-a259-4843-91ca-0f6173b4ded7" providerId="AD" clId="Web-{ABD2D9A6-6AE6-4DAE-7E6E-EB84A508C742}" dt="2019-10-07T02:31:04.309" v="5"/>
          <ac:spMkLst>
            <pc:docMk/>
            <pc:sldMk cId="3602664236" sldId="288"/>
            <ac:spMk id="319" creationId="{00000000-0000-0000-0000-000000000000}"/>
          </ac:spMkLst>
        </pc:spChg>
        <pc:grpChg chg="del">
          <ac:chgData name="MITSUZAWA Shigenobu" userId="S::722940@jp.honda-ri.com::dea47e31-a259-4843-91ca-0f6173b4ded7" providerId="AD" clId="Web-{ABD2D9A6-6AE6-4DAE-7E6E-EB84A508C742}" dt="2019-10-07T02:31:06.965" v="6"/>
          <ac:grpSpMkLst>
            <pc:docMk/>
            <pc:sldMk cId="3602664236" sldId="288"/>
            <ac:grpSpMk id="26" creationId="{00000000-0000-0000-0000-000000000000}"/>
          </ac:grpSpMkLst>
        </pc:grpChg>
      </pc:sldChg>
    </pc:docChg>
  </pc:docChgLst>
  <pc:docChgLst>
    <pc:chgData name="SHINKAWA Satoru" userId="S::323329@jp.honda-ri.com::c45c76bf-e864-4554-8776-a99736ef45b7" providerId="AD" clId="Web-{5AC1333F-34DF-1AB0-D7D5-EB79C57C7BE8}"/>
    <pc:docChg chg="modSld">
      <pc:chgData name="SHINKAWA Satoru" userId="S::323329@jp.honda-ri.com::c45c76bf-e864-4554-8776-a99736ef45b7" providerId="AD" clId="Web-{5AC1333F-34DF-1AB0-D7D5-EB79C57C7BE8}" dt="2019-06-25T07:02:12.898" v="136" actId="20577"/>
      <pc:docMkLst>
        <pc:docMk/>
      </pc:docMkLst>
      <pc:sldChg chg="addSp delSp modSp">
        <pc:chgData name="SHINKAWA Satoru" userId="S::323329@jp.honda-ri.com::c45c76bf-e864-4554-8776-a99736ef45b7" providerId="AD" clId="Web-{5AC1333F-34DF-1AB0-D7D5-EB79C57C7BE8}" dt="2019-06-25T07:02:09.211" v="134" actId="20577"/>
        <pc:sldMkLst>
          <pc:docMk/>
          <pc:sldMk cId="2558221072" sldId="257"/>
        </pc:sldMkLst>
        <pc:spChg chg="del">
          <ac:chgData name="SHINKAWA Satoru" userId="S::323329@jp.honda-ri.com::c45c76bf-e864-4554-8776-a99736ef45b7" providerId="AD" clId="Web-{5AC1333F-34DF-1AB0-D7D5-EB79C57C7BE8}" dt="2019-06-25T06:48:36.381" v="3"/>
          <ac:spMkLst>
            <pc:docMk/>
            <pc:sldMk cId="2558221072" sldId="257"/>
            <ac:spMk id="3" creationId="{00000000-0000-0000-0000-000000000000}"/>
          </ac:spMkLst>
        </pc:spChg>
        <pc:spChg chg="del">
          <ac:chgData name="SHINKAWA Satoru" userId="S::323329@jp.honda-ri.com::c45c76bf-e864-4554-8776-a99736ef45b7" providerId="AD" clId="Web-{5AC1333F-34DF-1AB0-D7D5-EB79C57C7BE8}" dt="2019-06-25T06:48:32.584" v="2"/>
          <ac:spMkLst>
            <pc:docMk/>
            <pc:sldMk cId="2558221072" sldId="257"/>
            <ac:spMk id="5" creationId="{00000000-0000-0000-0000-000000000000}"/>
          </ac:spMkLst>
        </pc:spChg>
        <pc:spChg chg="mod">
          <ac:chgData name="SHINKAWA Satoru" userId="S::323329@jp.honda-ri.com::c45c76bf-e864-4554-8776-a99736ef45b7" providerId="AD" clId="Web-{5AC1333F-34DF-1AB0-D7D5-EB79C57C7BE8}" dt="2019-06-25T07:02:09.211" v="134" actId="20577"/>
          <ac:spMkLst>
            <pc:docMk/>
            <pc:sldMk cId="2558221072" sldId="257"/>
            <ac:spMk id="6" creationId="{00000000-0000-0000-0000-000000000000}"/>
          </ac:spMkLst>
        </pc:spChg>
        <pc:spChg chg="del mod">
          <ac:chgData name="SHINKAWA Satoru" userId="S::323329@jp.honda-ri.com::c45c76bf-e864-4554-8776-a99736ef45b7" providerId="AD" clId="Web-{5AC1333F-34DF-1AB0-D7D5-EB79C57C7BE8}" dt="2019-06-25T06:59:56.398" v="110"/>
          <ac:spMkLst>
            <pc:docMk/>
            <pc:sldMk cId="2558221072" sldId="257"/>
            <ac:spMk id="7" creationId="{00000000-0000-0000-0000-000000000000}"/>
          </ac:spMkLst>
        </pc:spChg>
        <pc:spChg chg="mod">
          <ac:chgData name="SHINKAWA Satoru" userId="S::323329@jp.honda-ri.com::c45c76bf-e864-4554-8776-a99736ef45b7" providerId="AD" clId="Web-{5AC1333F-34DF-1AB0-D7D5-EB79C57C7BE8}" dt="2019-06-25T07:00:46.320" v="115" actId="20577"/>
          <ac:spMkLst>
            <pc:docMk/>
            <pc:sldMk cId="2558221072" sldId="257"/>
            <ac:spMk id="11" creationId="{00000000-0000-0000-0000-000000000000}"/>
          </ac:spMkLst>
        </pc:spChg>
        <pc:spChg chg="add del mod">
          <ac:chgData name="SHINKAWA Satoru" userId="S::323329@jp.honda-ri.com::c45c76bf-e864-4554-8776-a99736ef45b7" providerId="AD" clId="Web-{5AC1333F-34DF-1AB0-D7D5-EB79C57C7BE8}" dt="2019-06-25T06:58:37.663" v="53"/>
          <ac:spMkLst>
            <pc:docMk/>
            <pc:sldMk cId="2558221072" sldId="257"/>
            <ac:spMk id="12" creationId="{579A91A5-0D28-4D65-B6B7-FA1B9BBC71ED}"/>
          </ac:spMkLst>
        </pc:spChg>
        <pc:picChg chg="mod">
          <ac:chgData name="SHINKAWA Satoru" userId="S::323329@jp.honda-ri.com::c45c76bf-e864-4554-8776-a99736ef45b7" providerId="AD" clId="Web-{5AC1333F-34DF-1AB0-D7D5-EB79C57C7BE8}" dt="2019-06-25T07:00:03.960" v="111" actId="1076"/>
          <ac:picMkLst>
            <pc:docMk/>
            <pc:sldMk cId="2558221072" sldId="257"/>
            <ac:picMk id="4" creationId="{00000000-0000-0000-0000-000000000000}"/>
          </ac:picMkLst>
        </pc:picChg>
      </pc:sldChg>
    </pc:docChg>
  </pc:docChgLst>
  <pc:docChgLst>
    <pc:chgData name="SHINKAWA Satoru" userId="S::323329@jp.honda-ri.com::c45c76bf-e864-4554-8776-a99736ef45b7" providerId="AD" clId="Web-{820B1BDD-8D69-AA17-B677-F0A7702F3FF8}"/>
    <pc:docChg chg="modSld">
      <pc:chgData name="SHINKAWA Satoru" userId="S::323329@jp.honda-ri.com::c45c76bf-e864-4554-8776-a99736ef45b7" providerId="AD" clId="Web-{820B1BDD-8D69-AA17-B677-F0A7702F3FF8}" dt="2019-06-21T06:30:19.085" v="2"/>
      <pc:docMkLst>
        <pc:docMk/>
      </pc:docMkLst>
      <pc:sldChg chg="addSp delSp modSp">
        <pc:chgData name="SHINKAWA Satoru" userId="S::323329@jp.honda-ri.com::c45c76bf-e864-4554-8776-a99736ef45b7" providerId="AD" clId="Web-{820B1BDD-8D69-AA17-B677-F0A7702F3FF8}" dt="2019-06-21T06:30:19.085" v="2"/>
        <pc:sldMkLst>
          <pc:docMk/>
          <pc:sldMk cId="658570852" sldId="272"/>
        </pc:sldMkLst>
        <pc:picChg chg="mod">
          <ac:chgData name="SHINKAWA Satoru" userId="S::323329@jp.honda-ri.com::c45c76bf-e864-4554-8776-a99736ef45b7" providerId="AD" clId="Web-{820B1BDD-8D69-AA17-B677-F0A7702F3FF8}" dt="2019-06-21T06:30:05.117" v="0" actId="1076"/>
          <ac:picMkLst>
            <pc:docMk/>
            <pc:sldMk cId="658570852" sldId="272"/>
            <ac:picMk id="4" creationId="{00000000-0000-0000-0000-000000000000}"/>
          </ac:picMkLst>
        </pc:picChg>
        <pc:picChg chg="add del mod">
          <ac:chgData name="SHINKAWA Satoru" userId="S::323329@jp.honda-ri.com::c45c76bf-e864-4554-8776-a99736ef45b7" providerId="AD" clId="Web-{820B1BDD-8D69-AA17-B677-F0A7702F3FF8}" dt="2019-06-21T06:30:19.085" v="2"/>
          <ac:picMkLst>
            <pc:docMk/>
            <pc:sldMk cId="658570852" sldId="272"/>
            <ac:picMk id="6" creationId="{021D95BB-54B5-45F5-8DD9-86C137F16BB8}"/>
          </ac:picMkLst>
        </pc:picChg>
      </pc:sldChg>
    </pc:docChg>
  </pc:docChgLst>
  <pc:docChgLst>
    <pc:chgData name="MITSUZAWA Shigenobu" userId="S::722940@jp.honda-ri.com::dea47e31-a259-4843-91ca-0f6173b4ded7" providerId="AD" clId="Web-{0027EA7B-7F24-0ABD-6537-DBADD8D8F587}"/>
    <pc:docChg chg="sldOrd">
      <pc:chgData name="MITSUZAWA Shigenobu" userId="S::722940@jp.honda-ri.com::dea47e31-a259-4843-91ca-0f6173b4ded7" providerId="AD" clId="Web-{0027EA7B-7F24-0ABD-6537-DBADD8D8F587}" dt="2019-10-07T02:34:20.464" v="1"/>
      <pc:docMkLst>
        <pc:docMk/>
      </pc:docMkLst>
      <pc:sldChg chg="ord">
        <pc:chgData name="MITSUZAWA Shigenobu" userId="S::722940@jp.honda-ri.com::dea47e31-a259-4843-91ca-0f6173b4ded7" providerId="AD" clId="Web-{0027EA7B-7F24-0ABD-6537-DBADD8D8F587}" dt="2019-10-07T02:33:43.635" v="0"/>
        <pc:sldMkLst>
          <pc:docMk/>
          <pc:sldMk cId="531892977" sldId="256"/>
        </pc:sldMkLst>
      </pc:sldChg>
      <pc:sldChg chg="ord">
        <pc:chgData name="MITSUZAWA Shigenobu" userId="S::722940@jp.honda-ri.com::dea47e31-a259-4843-91ca-0f6173b4ded7" providerId="AD" clId="Web-{0027EA7B-7F24-0ABD-6537-DBADD8D8F587}" dt="2019-10-07T02:34:20.464" v="1"/>
        <pc:sldMkLst>
          <pc:docMk/>
          <pc:sldMk cId="4232154430" sldId="282"/>
        </pc:sldMkLst>
      </pc:sldChg>
    </pc:docChg>
  </pc:docChgLst>
  <pc:docChgLst>
    <pc:chgData name="SHINKAWA Satoru" userId="S::323329@jp.honda-ri.com::c45c76bf-e864-4554-8776-a99736ef45b7" providerId="AD" clId="Web-{68EEA754-8403-A4C4-099D-4EAAAE87E0E3}"/>
    <pc:docChg chg="modSld">
      <pc:chgData name="SHINKAWA Satoru" userId="S::323329@jp.honda-ri.com::c45c76bf-e864-4554-8776-a99736ef45b7" providerId="AD" clId="Web-{68EEA754-8403-A4C4-099D-4EAAAE87E0E3}" dt="2019-06-18T07:45:44.381" v="3" actId="20577"/>
      <pc:docMkLst>
        <pc:docMk/>
      </pc:docMkLst>
      <pc:sldChg chg="modSp">
        <pc:chgData name="SHINKAWA Satoru" userId="S::323329@jp.honda-ri.com::c45c76bf-e864-4554-8776-a99736ef45b7" providerId="AD" clId="Web-{68EEA754-8403-A4C4-099D-4EAAAE87E0E3}" dt="2019-06-18T07:45:44.381" v="2" actId="20577"/>
        <pc:sldMkLst>
          <pc:docMk/>
          <pc:sldMk cId="690213262" sldId="278"/>
        </pc:sldMkLst>
        <pc:spChg chg="mod">
          <ac:chgData name="SHINKAWA Satoru" userId="S::323329@jp.honda-ri.com::c45c76bf-e864-4554-8776-a99736ef45b7" providerId="AD" clId="Web-{68EEA754-8403-A4C4-099D-4EAAAE87E0E3}" dt="2019-06-18T07:45:44.381" v="2" actId="20577"/>
          <ac:spMkLst>
            <pc:docMk/>
            <pc:sldMk cId="690213262" sldId="278"/>
            <ac:spMk id="6" creationId="{00000000-0000-0000-0000-000000000000}"/>
          </ac:spMkLst>
        </pc:spChg>
      </pc:sldChg>
    </pc:docChg>
  </pc:docChgLst>
  <pc:docChgLst>
    <pc:chgData name="SHINKAWA Satoru" userId="S::323329@jp.honda-ri.com::c45c76bf-e864-4554-8776-a99736ef45b7" providerId="AD" clId="Web-{B1227DA5-5ACA-AFBA-7F14-27659559053A}"/>
    <pc:docChg chg="modSld">
      <pc:chgData name="SHINKAWA Satoru" userId="S::323329@jp.honda-ri.com::c45c76bf-e864-4554-8776-a99736ef45b7" providerId="AD" clId="Web-{B1227DA5-5ACA-AFBA-7F14-27659559053A}" dt="2019-09-06T04:20:17.706" v="2"/>
      <pc:docMkLst>
        <pc:docMk/>
      </pc:docMkLst>
      <pc:sldChg chg="addSp delSp modSp">
        <pc:chgData name="SHINKAWA Satoru" userId="S::323329@jp.honda-ri.com::c45c76bf-e864-4554-8776-a99736ef45b7" providerId="AD" clId="Web-{B1227DA5-5ACA-AFBA-7F14-27659559053A}" dt="2019-09-06T04:20:17.706" v="2"/>
        <pc:sldMkLst>
          <pc:docMk/>
          <pc:sldMk cId="940661961" sldId="280"/>
        </pc:sldMkLst>
        <pc:spChg chg="add del mod">
          <ac:chgData name="SHINKAWA Satoru" userId="S::323329@jp.honda-ri.com::c45c76bf-e864-4554-8776-a99736ef45b7" providerId="AD" clId="Web-{B1227DA5-5ACA-AFBA-7F14-27659559053A}" dt="2019-09-06T04:20:17.706" v="2"/>
          <ac:spMkLst>
            <pc:docMk/>
            <pc:sldMk cId="940661961" sldId="280"/>
            <ac:spMk id="69" creationId="{2541848E-E721-4080-B2C8-B6B903E38822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67251C-7B49-4269-996D-A0D85004B2B5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934E2D2-4AA9-40B7-860D-98CB78C75DF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363820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4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742535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89251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6" y="365126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1" y="365126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75005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754542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9" y="1709740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9" y="4589465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04147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1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49389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2" y="365127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4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1" y="1681164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1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46109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1857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077545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7"/>
            <a:ext cx="4629151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51974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9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7"/>
            <a:ext cx="4629151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9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93490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1" y="365127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1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528131-800C-4B62-A791-C0CAF6C7EDC9}" type="datetimeFigureOut">
              <a:rPr kumimoji="1" lang="ja-JP" altLang="en-US" smtClean="0"/>
              <a:t>2020/1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1" y="6356352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1" y="6356352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FB19AF-D082-4C07-B06E-C1A1E6B194F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97565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468" t="16265" r="10992"/>
          <a:stretch/>
        </p:blipFill>
        <p:spPr>
          <a:xfrm>
            <a:off x="222444" y="438307"/>
            <a:ext cx="2077200" cy="1764000"/>
          </a:xfrm>
          <a:prstGeom prst="rect">
            <a:avLst/>
          </a:prstGeom>
        </p:spPr>
      </p:pic>
      <p:sp>
        <p:nvSpPr>
          <p:cNvPr id="13" name="正方形/長方形 12"/>
          <p:cNvSpPr/>
          <p:nvPr/>
        </p:nvSpPr>
        <p:spPr>
          <a:xfrm>
            <a:off x="724903" y="2132159"/>
            <a:ext cx="1072281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ea typeface="Meiryo UI" panose="020B0604030504040204" pitchFamily="50" charset="-128"/>
                <a:cs typeface="Times New Roman" panose="02020603050405020304" pitchFamily="18" charset="0"/>
              </a:rPr>
              <a:t>Strain RIB40</a:t>
            </a:r>
            <a:endParaRPr kumimoji="1" lang="ja-JP" altLang="en-US" sz="1400" dirty="0"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14" name="図 13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438" t="13956" r="10858"/>
          <a:stretch/>
        </p:blipFill>
        <p:spPr>
          <a:xfrm>
            <a:off x="2400178" y="438307"/>
            <a:ext cx="2077200" cy="1764000"/>
          </a:xfrm>
          <a:prstGeom prst="rect">
            <a:avLst/>
          </a:prstGeom>
        </p:spPr>
      </p:pic>
      <p:sp>
        <p:nvSpPr>
          <p:cNvPr id="15" name="正方形/長方形 14"/>
          <p:cNvSpPr/>
          <p:nvPr/>
        </p:nvSpPr>
        <p:spPr>
          <a:xfrm>
            <a:off x="2865959" y="2132159"/>
            <a:ext cx="11456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ea typeface="Meiryo UI" panose="020B0604030504040204" pitchFamily="50" charset="-128"/>
                <a:cs typeface="Times New Roman" panose="02020603050405020304" pitchFamily="18" charset="0"/>
              </a:rPr>
              <a:t>Strain </a:t>
            </a:r>
            <a:r>
              <a:rPr lang="en-US" altLang="ja-JP" sz="1400" dirty="0" smtClean="0">
                <a:ea typeface="Meiryo UI" panose="020B0604030504040204" pitchFamily="50" charset="-128"/>
                <a:cs typeface="Times New Roman" panose="02020603050405020304" pitchFamily="18" charset="0"/>
              </a:rPr>
              <a:t>AOK20</a:t>
            </a:r>
            <a:endParaRPr kumimoji="1" lang="ja-JP" altLang="en-US" sz="1400" dirty="0"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16" name="図 15"/>
          <p:cNvPicPr>
            <a:picLocks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132" t="16808" r="7882"/>
          <a:stretch/>
        </p:blipFill>
        <p:spPr>
          <a:xfrm>
            <a:off x="4582827" y="438307"/>
            <a:ext cx="2077200" cy="1764000"/>
          </a:xfrm>
          <a:prstGeom prst="rect">
            <a:avLst/>
          </a:prstGeom>
        </p:spPr>
      </p:pic>
      <p:sp>
        <p:nvSpPr>
          <p:cNvPr id="17" name="正方形/長方形 16"/>
          <p:cNvSpPr/>
          <p:nvPr/>
        </p:nvSpPr>
        <p:spPr>
          <a:xfrm>
            <a:off x="5047808" y="2132159"/>
            <a:ext cx="1147237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ea typeface="Meiryo UI" panose="020B0604030504040204" pitchFamily="50" charset="-128"/>
                <a:cs typeface="Times New Roman" panose="02020603050405020304" pitchFamily="18" charset="0"/>
              </a:rPr>
              <a:t>Strain </a:t>
            </a:r>
            <a:r>
              <a:rPr lang="en-US" altLang="ja-JP" sz="1400" dirty="0" smtClean="0">
                <a:ea typeface="Meiryo UI" panose="020B0604030504040204" pitchFamily="50" charset="-128"/>
                <a:cs typeface="Times New Roman" panose="02020603050405020304" pitchFamily="18" charset="0"/>
              </a:rPr>
              <a:t>AOK2P</a:t>
            </a:r>
            <a:endParaRPr kumimoji="1" lang="ja-JP" altLang="en-US" sz="1400" dirty="0"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18" name="図 17"/>
          <p:cNvPicPr>
            <a:picLocks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089" t="14949" r="6208"/>
          <a:stretch/>
        </p:blipFill>
        <p:spPr>
          <a:xfrm>
            <a:off x="6771936" y="438307"/>
            <a:ext cx="2077200" cy="1764000"/>
          </a:xfrm>
          <a:prstGeom prst="rect">
            <a:avLst/>
          </a:prstGeom>
        </p:spPr>
      </p:pic>
      <p:sp>
        <p:nvSpPr>
          <p:cNvPr id="19" name="正方形/長方形 18"/>
          <p:cNvSpPr/>
          <p:nvPr/>
        </p:nvSpPr>
        <p:spPr>
          <a:xfrm>
            <a:off x="7177261" y="2132159"/>
            <a:ext cx="114563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ea typeface="Meiryo UI" panose="020B0604030504040204" pitchFamily="50" charset="-128"/>
                <a:cs typeface="Times New Roman" panose="02020603050405020304" pitchFamily="18" charset="0"/>
              </a:rPr>
              <a:t>Strain </a:t>
            </a:r>
            <a:r>
              <a:rPr lang="en-US" altLang="ja-JP" sz="1400" dirty="0" smtClean="0">
                <a:ea typeface="Meiryo UI" panose="020B0604030504040204" pitchFamily="50" charset="-128"/>
                <a:cs typeface="Times New Roman" panose="02020603050405020304" pitchFamily="18" charset="0"/>
              </a:rPr>
              <a:t>AOK65</a:t>
            </a:r>
            <a:endParaRPr kumimoji="1" lang="ja-JP" altLang="en-US" sz="1400" dirty="0"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sp>
        <p:nvSpPr>
          <p:cNvPr id="20" name="正方形/長方形 19"/>
          <p:cNvSpPr/>
          <p:nvPr/>
        </p:nvSpPr>
        <p:spPr>
          <a:xfrm>
            <a:off x="645053" y="4239773"/>
            <a:ext cx="12370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ea typeface="Meiryo UI" panose="020B0604030504040204" pitchFamily="50" charset="-128"/>
                <a:cs typeface="Times New Roman" panose="02020603050405020304" pitchFamily="18" charset="0"/>
              </a:rPr>
              <a:t>Strain </a:t>
            </a:r>
            <a:r>
              <a:rPr lang="en-US" altLang="ja-JP" sz="1400" dirty="0" smtClean="0">
                <a:ea typeface="Meiryo UI" panose="020B0604030504040204" pitchFamily="50" charset="-128"/>
                <a:cs typeface="Times New Roman" panose="02020603050405020304" pitchFamily="18" charset="0"/>
              </a:rPr>
              <a:t>AOK241</a:t>
            </a:r>
            <a:endParaRPr kumimoji="1" lang="ja-JP" altLang="en-US" sz="1400" dirty="0"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21" name="図 20"/>
          <p:cNvPicPr>
            <a:picLocks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80" t="10733" r="6673"/>
          <a:stretch/>
        </p:blipFill>
        <p:spPr>
          <a:xfrm>
            <a:off x="222444" y="2523984"/>
            <a:ext cx="2077200" cy="1764000"/>
          </a:xfrm>
          <a:prstGeom prst="rect">
            <a:avLst/>
          </a:prstGeom>
        </p:spPr>
      </p:pic>
      <p:pic>
        <p:nvPicPr>
          <p:cNvPr id="22" name="図 21"/>
          <p:cNvPicPr>
            <a:picLocks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91" t="6643" r="5930"/>
          <a:stretch/>
        </p:blipFill>
        <p:spPr>
          <a:xfrm>
            <a:off x="2400178" y="2523984"/>
            <a:ext cx="2077200" cy="1764000"/>
          </a:xfrm>
          <a:prstGeom prst="rect">
            <a:avLst/>
          </a:prstGeom>
        </p:spPr>
      </p:pic>
      <p:sp>
        <p:nvSpPr>
          <p:cNvPr id="23" name="正方形/長方形 22"/>
          <p:cNvSpPr/>
          <p:nvPr/>
        </p:nvSpPr>
        <p:spPr>
          <a:xfrm>
            <a:off x="2820274" y="4239773"/>
            <a:ext cx="12370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ea typeface="Meiryo UI" panose="020B0604030504040204" pitchFamily="50" charset="-128"/>
                <a:cs typeface="Times New Roman" panose="02020603050405020304" pitchFamily="18" charset="0"/>
              </a:rPr>
              <a:t>Strain </a:t>
            </a:r>
            <a:r>
              <a:rPr lang="en-US" altLang="ja-JP" sz="1400" dirty="0" smtClean="0">
                <a:ea typeface="Meiryo UI" panose="020B0604030504040204" pitchFamily="50" charset="-128"/>
                <a:cs typeface="Times New Roman" panose="02020603050405020304" pitchFamily="18" charset="0"/>
              </a:rPr>
              <a:t>AOK210</a:t>
            </a:r>
            <a:endParaRPr kumimoji="1" lang="ja-JP" altLang="en-US" sz="1400" dirty="0"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24" name="図 23"/>
          <p:cNvPicPr>
            <a:picLocks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24" t="8750" r="5186"/>
          <a:stretch/>
        </p:blipFill>
        <p:spPr>
          <a:xfrm>
            <a:off x="4582827" y="2523985"/>
            <a:ext cx="2077200" cy="1764000"/>
          </a:xfrm>
          <a:prstGeom prst="rect">
            <a:avLst/>
          </a:prstGeom>
        </p:spPr>
      </p:pic>
      <p:sp>
        <p:nvSpPr>
          <p:cNvPr id="25" name="正方形/長方形 24"/>
          <p:cNvSpPr/>
          <p:nvPr/>
        </p:nvSpPr>
        <p:spPr>
          <a:xfrm>
            <a:off x="5014169" y="4239773"/>
            <a:ext cx="122097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ea typeface="Meiryo UI" panose="020B0604030504040204" pitchFamily="50" charset="-128"/>
                <a:cs typeface="Times New Roman" panose="02020603050405020304" pitchFamily="18" charset="0"/>
              </a:rPr>
              <a:t>Strain </a:t>
            </a:r>
            <a:r>
              <a:rPr lang="en-US" altLang="ja-JP" sz="1400" dirty="0" smtClean="0">
                <a:ea typeface="Meiryo UI" panose="020B0604030504040204" pitchFamily="50" charset="-128"/>
                <a:cs typeface="Times New Roman" panose="02020603050405020304" pitchFamily="18" charset="0"/>
              </a:rPr>
              <a:t>AOK27L</a:t>
            </a:r>
            <a:endParaRPr kumimoji="1" lang="ja-JP" altLang="en-US" sz="1400" dirty="0"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26" name="図 25"/>
          <p:cNvPicPr>
            <a:picLocks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043" t="12469" r="6023"/>
          <a:stretch/>
        </p:blipFill>
        <p:spPr>
          <a:xfrm>
            <a:off x="6771936" y="2523985"/>
            <a:ext cx="2077200" cy="1764000"/>
          </a:xfrm>
          <a:prstGeom prst="rect">
            <a:avLst/>
          </a:prstGeom>
        </p:spPr>
      </p:pic>
      <p:sp>
        <p:nvSpPr>
          <p:cNvPr id="27" name="正方形/長方形 26"/>
          <p:cNvSpPr/>
          <p:nvPr/>
        </p:nvSpPr>
        <p:spPr>
          <a:xfrm>
            <a:off x="7131576" y="4239773"/>
            <a:ext cx="1237005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sz="1400" dirty="0">
                <a:ea typeface="Meiryo UI" panose="020B0604030504040204" pitchFamily="50" charset="-128"/>
                <a:cs typeface="Times New Roman" panose="02020603050405020304" pitchFamily="18" charset="0"/>
              </a:rPr>
              <a:t>Strain </a:t>
            </a:r>
            <a:r>
              <a:rPr lang="en-US" altLang="ja-JP" sz="1400" dirty="0" smtClean="0">
                <a:ea typeface="Meiryo UI" panose="020B0604030504040204" pitchFamily="50" charset="-128"/>
                <a:cs typeface="Times New Roman" panose="02020603050405020304" pitchFamily="18" charset="0"/>
              </a:rPr>
              <a:t>AOK139</a:t>
            </a:r>
            <a:endParaRPr kumimoji="1" lang="ja-JP" altLang="en-US" sz="1400" dirty="0"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  <p:pic>
        <p:nvPicPr>
          <p:cNvPr id="28" name="図 27"/>
          <p:cNvPicPr>
            <a:picLocks/>
          </p:cNvPicPr>
          <p:nvPr/>
        </p:nvPicPr>
        <p:blipFill rotWithShape="1"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903" t="10238" r="9277"/>
          <a:stretch/>
        </p:blipFill>
        <p:spPr>
          <a:xfrm>
            <a:off x="222444" y="4670240"/>
            <a:ext cx="2077200" cy="1764000"/>
          </a:xfrm>
          <a:prstGeom prst="rect">
            <a:avLst/>
          </a:prstGeom>
        </p:spPr>
      </p:pic>
      <p:sp>
        <p:nvSpPr>
          <p:cNvPr id="29" name="テキスト ボックス 28"/>
          <p:cNvSpPr txBox="1"/>
          <p:nvPr/>
        </p:nvSpPr>
        <p:spPr>
          <a:xfrm>
            <a:off x="121910" y="-22086"/>
            <a:ext cx="147668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cs typeface="Helvetica" pitchFamily="34" charset="0"/>
              </a:rPr>
              <a:t>FIGURE </a:t>
            </a:r>
            <a:r>
              <a:rPr kumimoji="1" lang="en-US" altLang="ja-JP" sz="2400" dirty="0" smtClean="0">
                <a:cs typeface="Helvetica" pitchFamily="34" charset="0"/>
              </a:rPr>
              <a:t>S1</a:t>
            </a:r>
            <a:endParaRPr kumimoji="1" lang="ja-JP" altLang="en-US" sz="2400" dirty="0">
              <a:cs typeface="Helvetica" pitchFamily="34" charset="0"/>
            </a:endParaRPr>
          </a:p>
        </p:txBody>
      </p:sp>
      <p:sp>
        <p:nvSpPr>
          <p:cNvPr id="30" name="テキスト ボックス 29"/>
          <p:cNvSpPr txBox="1"/>
          <p:nvPr/>
        </p:nvSpPr>
        <p:spPr>
          <a:xfrm>
            <a:off x="325560" y="6434240"/>
            <a:ext cx="187096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400" dirty="0" smtClean="0">
                <a:ea typeface="Meiryo UI" panose="020B0604030504040204" pitchFamily="50" charset="-128"/>
                <a:cs typeface="Times New Roman" panose="02020603050405020304" pitchFamily="18" charset="0"/>
              </a:rPr>
              <a:t>No inoculation (NI)</a:t>
            </a:r>
            <a:endParaRPr kumimoji="1" lang="ja-JP" altLang="en-US" sz="1400" dirty="0">
              <a:ea typeface="Meiryo UI" panose="020B060403050404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943009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75</TotalTime>
  <Words>23</Words>
  <Application>Microsoft Office PowerPoint</Application>
  <PresentationFormat>画面に合わせる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Meiryo UI</vt:lpstr>
      <vt:lpstr>游ゴシック</vt:lpstr>
      <vt:lpstr>游ゴシック Light</vt:lpstr>
      <vt:lpstr>Arial</vt:lpstr>
      <vt:lpstr>Calibri</vt:lpstr>
      <vt:lpstr>Calibri Light</vt:lpstr>
      <vt:lpstr>Helvetica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INKAWA Satoru</dc:creator>
  <cp:lastModifiedBy>SHINKAWA Satoru</cp:lastModifiedBy>
  <cp:revision>89</cp:revision>
  <dcterms:created xsi:type="dcterms:W3CDTF">2019-02-15T05:38:43Z</dcterms:created>
  <dcterms:modified xsi:type="dcterms:W3CDTF">2020-01-13T03:30:25Z</dcterms:modified>
</cp:coreProperties>
</file>